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44" y="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florida-my.sharepoint.com/personal/yoonjeon_jang_ufl_edu/Documents/2)%20Paper_Yoonjeong%20Jang/Brilliance_PNAS/FaRCa1_fig_revised_JYJ/gene%20expression/real%20time%20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uflorida-my.sharepoint.com/personal/yoonjeon_jang_ufl_edu/Documents/2)%20Paper_Yoonjeong%20Jang/Brilliance_PNAS/FaRCa1_fig_revised_JYJ/gene%20expression/real%20time%20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2FE-4095-883C-2A0D4D4D0A9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2FE-4095-883C-2A0D4D4D0A92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2FE-4095-883C-2A0D4D4D0A92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B2FE-4095-883C-2A0D4D4D0A92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2FE-4095-883C-2A0D4D4D0A92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2FE-4095-883C-2A0D4D4D0A92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B2FE-4095-883C-2A0D4D4D0A92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2FE-4095-883C-2A0D4D4D0A92}"/>
              </c:ext>
            </c:extLst>
          </c:dPt>
          <c:dPt>
            <c:idx val="8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2FE-4095-883C-2A0D4D4D0A92}"/>
              </c:ext>
            </c:extLst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B2FE-4095-883C-2A0D4D4D0A92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B2FE-4095-883C-2A0D4D4D0A92}"/>
              </c:ext>
            </c:extLst>
          </c:dPt>
          <c:dPt>
            <c:idx val="1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B2FE-4095-883C-2A0D4D4D0A92}"/>
              </c:ext>
            </c:extLst>
          </c:dPt>
          <c:errBars>
            <c:errBarType val="plus"/>
            <c:errValType val="cust"/>
            <c:noEndCap val="0"/>
            <c:plus>
              <c:numRef>
                <c:f>'163.0_F1 Livak B'!$AK$27:$AK$38</c:f>
                <c:numCache>
                  <c:formatCode>General</c:formatCode>
                  <c:ptCount val="12"/>
                  <c:pt idx="0">
                    <c:v>0.21217677786403732</c:v>
                  </c:pt>
                  <c:pt idx="1">
                    <c:v>0.36803468458931593</c:v>
                  </c:pt>
                  <c:pt idx="2">
                    <c:v>0.21038587001769812</c:v>
                  </c:pt>
                  <c:pt idx="3">
                    <c:v>8.8640038231499838E-2</c:v>
                  </c:pt>
                  <c:pt idx="4">
                    <c:v>0.26414323621200525</c:v>
                  </c:pt>
                  <c:pt idx="5">
                    <c:v>8.0188011783237381E-2</c:v>
                  </c:pt>
                  <c:pt idx="6">
                    <c:v>8.8934777784815996E-2</c:v>
                  </c:pt>
                  <c:pt idx="7">
                    <c:v>0.41915727466628905</c:v>
                  </c:pt>
                  <c:pt idx="8">
                    <c:v>8.9555550907890635E-2</c:v>
                  </c:pt>
                  <c:pt idx="9">
                    <c:v>8.4491726798602382E-2</c:v>
                  </c:pt>
                  <c:pt idx="10">
                    <c:v>0.25055662473782836</c:v>
                  </c:pt>
                  <c:pt idx="11">
                    <c:v>0.119960906873444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163.0_F1 Livak B'!$AI$27:$AJ$38</c:f>
              <c:multiLvlStrCache>
                <c:ptCount val="12"/>
                <c:lvl>
                  <c:pt idx="0">
                    <c:v>AA_24hpi</c:v>
                  </c:pt>
                  <c:pt idx="1">
                    <c:v>AB_24hpi</c:v>
                  </c:pt>
                  <c:pt idx="2">
                    <c:v>BB_24hpi</c:v>
                  </c:pt>
                  <c:pt idx="3">
                    <c:v>AA_48hpi</c:v>
                  </c:pt>
                  <c:pt idx="4">
                    <c:v>AB_48hpi</c:v>
                  </c:pt>
                  <c:pt idx="5">
                    <c:v>BB_48hpi</c:v>
                  </c:pt>
                  <c:pt idx="6">
                    <c:v>AA_72hpi</c:v>
                  </c:pt>
                  <c:pt idx="7">
                    <c:v>AB_72hpi</c:v>
                  </c:pt>
                  <c:pt idx="8">
                    <c:v>BB_72hpi</c:v>
                  </c:pt>
                  <c:pt idx="9">
                    <c:v>AA_96hpi</c:v>
                  </c:pt>
                  <c:pt idx="10">
                    <c:v>AB_96hpi</c:v>
                  </c:pt>
                  <c:pt idx="11">
                    <c:v>BB_96hpi</c:v>
                  </c:pt>
                </c:lvl>
                <c:lvl>
                  <c:pt idx="0">
                    <c:v>24hpi</c:v>
                  </c:pt>
                  <c:pt idx="3">
                    <c:v>48hpi</c:v>
                  </c:pt>
                  <c:pt idx="6">
                    <c:v>72hpi</c:v>
                  </c:pt>
                  <c:pt idx="9">
                    <c:v>96hpi</c:v>
                  </c:pt>
                </c:lvl>
              </c:multiLvlStrCache>
            </c:multiLvlStrRef>
          </c:cat>
          <c:val>
            <c:numRef>
              <c:f>'163.0_F1 Livak B'!$AL$27:$AL$38</c:f>
              <c:numCache>
                <c:formatCode>General</c:formatCode>
                <c:ptCount val="12"/>
                <c:pt idx="0">
                  <c:v>0.54373348731525195</c:v>
                </c:pt>
                <c:pt idx="1">
                  <c:v>1.2423353667931896</c:v>
                </c:pt>
                <c:pt idx="2">
                  <c:v>0.76634225007609824</c:v>
                </c:pt>
                <c:pt idx="3">
                  <c:v>0.30499991078000793</c:v>
                </c:pt>
                <c:pt idx="4">
                  <c:v>0.90190420360916335</c:v>
                </c:pt>
                <c:pt idx="5">
                  <c:v>0.26657592332895702</c:v>
                </c:pt>
                <c:pt idx="6">
                  <c:v>0.25619587162361562</c:v>
                </c:pt>
                <c:pt idx="7">
                  <c:v>1.2917513664096985</c:v>
                </c:pt>
                <c:pt idx="8">
                  <c:v>0.33209762656916392</c:v>
                </c:pt>
                <c:pt idx="9">
                  <c:v>0.27875836587633451</c:v>
                </c:pt>
                <c:pt idx="10">
                  <c:v>1.036163690255848</c:v>
                </c:pt>
                <c:pt idx="11">
                  <c:v>0.49712477771808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B2FE-4095-883C-2A0D4D4D0A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95156927"/>
        <c:axId val="1895152351"/>
      </c:barChart>
      <c:catAx>
        <c:axId val="18951569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95152351"/>
        <c:crosses val="autoZero"/>
        <c:auto val="1"/>
        <c:lblAlgn val="ctr"/>
        <c:lblOffset val="100"/>
        <c:noMultiLvlLbl val="0"/>
      </c:catAx>
      <c:valAx>
        <c:axId val="1895152351"/>
        <c:scaling>
          <c:orientation val="minMax"/>
          <c:max val="2.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9515692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CD4-44F2-9D1F-7B1866BE475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CD4-44F2-9D1F-7B1866BE475F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CD4-44F2-9D1F-7B1866BE475F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CD4-44F2-9D1F-7B1866BE475F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CD4-44F2-9D1F-7B1866BE475F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CD4-44F2-9D1F-7B1866BE475F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8CD4-44F2-9D1F-7B1866BE475F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8CD4-44F2-9D1F-7B1866BE475F}"/>
              </c:ext>
            </c:extLst>
          </c:dPt>
          <c:dPt>
            <c:idx val="8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8CD4-44F2-9D1F-7B1866BE475F}"/>
              </c:ext>
            </c:extLst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8CD4-44F2-9D1F-7B1866BE475F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8CD4-44F2-9D1F-7B1866BE475F}"/>
              </c:ext>
            </c:extLst>
          </c:dPt>
          <c:dPt>
            <c:idx val="1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8CD4-44F2-9D1F-7B1866BE475F}"/>
              </c:ext>
            </c:extLst>
          </c:dPt>
          <c:errBars>
            <c:errBarType val="plus"/>
            <c:errValType val="cust"/>
            <c:noEndCap val="0"/>
            <c:plus>
              <c:numRef>
                <c:f>'163.26_F1 Livak B'!$AJ$45:$AJ$56</c:f>
                <c:numCache>
                  <c:formatCode>General</c:formatCode>
                  <c:ptCount val="12"/>
                  <c:pt idx="0">
                    <c:v>0.15328092877224733</c:v>
                  </c:pt>
                  <c:pt idx="1">
                    <c:v>0.39178941418098195</c:v>
                  </c:pt>
                  <c:pt idx="2">
                    <c:v>0.28375172312456581</c:v>
                  </c:pt>
                  <c:pt idx="3">
                    <c:v>9.0168464774389778E-2</c:v>
                  </c:pt>
                  <c:pt idx="4">
                    <c:v>9.3430006348023051E-2</c:v>
                  </c:pt>
                  <c:pt idx="5">
                    <c:v>9.2945459060102167E-2</c:v>
                  </c:pt>
                  <c:pt idx="6">
                    <c:v>3.5202471859165189E-2</c:v>
                  </c:pt>
                  <c:pt idx="7">
                    <c:v>7.5656620767521263E-2</c:v>
                  </c:pt>
                  <c:pt idx="8">
                    <c:v>0.18583859138057199</c:v>
                  </c:pt>
                  <c:pt idx="9">
                    <c:v>3.9931904740298889E-2</c:v>
                  </c:pt>
                  <c:pt idx="10">
                    <c:v>0.4578201216487276</c:v>
                  </c:pt>
                  <c:pt idx="11">
                    <c:v>0.197310556311754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163.26_F1 Livak B'!$AH$45:$AI$56</c:f>
              <c:multiLvlStrCache>
                <c:ptCount val="12"/>
                <c:lvl>
                  <c:pt idx="0">
                    <c:v>AA_24hpi</c:v>
                  </c:pt>
                  <c:pt idx="1">
                    <c:v>AB_24hpi</c:v>
                  </c:pt>
                  <c:pt idx="2">
                    <c:v>BB_24hpi</c:v>
                  </c:pt>
                  <c:pt idx="3">
                    <c:v>AA_48hpi</c:v>
                  </c:pt>
                  <c:pt idx="4">
                    <c:v>AB_48hpi</c:v>
                  </c:pt>
                  <c:pt idx="5">
                    <c:v>BB_48hpi</c:v>
                  </c:pt>
                  <c:pt idx="6">
                    <c:v>AA_72hpi</c:v>
                  </c:pt>
                  <c:pt idx="7">
                    <c:v>AB_72hpi</c:v>
                  </c:pt>
                  <c:pt idx="8">
                    <c:v>BB_72hpi</c:v>
                  </c:pt>
                  <c:pt idx="9">
                    <c:v>AA_96hpi</c:v>
                  </c:pt>
                  <c:pt idx="10">
                    <c:v>AB_96hpi</c:v>
                  </c:pt>
                  <c:pt idx="11">
                    <c:v>BB_96hpi</c:v>
                  </c:pt>
                </c:lvl>
                <c:lvl>
                  <c:pt idx="0">
                    <c:v>24hpi</c:v>
                  </c:pt>
                  <c:pt idx="3">
                    <c:v>48hpi</c:v>
                  </c:pt>
                  <c:pt idx="6">
                    <c:v>72hpi</c:v>
                  </c:pt>
                  <c:pt idx="9">
                    <c:v>96hpi</c:v>
                  </c:pt>
                </c:lvl>
              </c:multiLvlStrCache>
            </c:multiLvlStrRef>
          </c:cat>
          <c:val>
            <c:numRef>
              <c:f>'163.26_F1 Livak B'!$AK$45:$AK$56</c:f>
              <c:numCache>
                <c:formatCode>General</c:formatCode>
                <c:ptCount val="12"/>
                <c:pt idx="0">
                  <c:v>1.0621985193841492</c:v>
                </c:pt>
                <c:pt idx="1">
                  <c:v>1.3943311876802122</c:v>
                </c:pt>
                <c:pt idx="2">
                  <c:v>1.6795872593921148</c:v>
                </c:pt>
                <c:pt idx="3">
                  <c:v>0.73946648202715159</c:v>
                </c:pt>
                <c:pt idx="4">
                  <c:v>1.3945891208378391</c:v>
                </c:pt>
                <c:pt idx="5">
                  <c:v>1.4230543834503413</c:v>
                </c:pt>
                <c:pt idx="6">
                  <c:v>0.55350634311991276</c:v>
                </c:pt>
                <c:pt idx="7">
                  <c:v>1.5520942725408642</c:v>
                </c:pt>
                <c:pt idx="8">
                  <c:v>1.7085849604802601</c:v>
                </c:pt>
                <c:pt idx="9">
                  <c:v>0.50096505984887518</c:v>
                </c:pt>
                <c:pt idx="10">
                  <c:v>1.9100551365108522</c:v>
                </c:pt>
                <c:pt idx="11">
                  <c:v>1.80910809896479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8CD4-44F2-9D1F-7B1866BE47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94743759"/>
        <c:axId val="1694752079"/>
      </c:barChart>
      <c:catAx>
        <c:axId val="16947437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694752079"/>
        <c:crosses val="autoZero"/>
        <c:auto val="1"/>
        <c:lblAlgn val="ctr"/>
        <c:lblOffset val="100"/>
        <c:noMultiLvlLbl val="0"/>
      </c:catAx>
      <c:valAx>
        <c:axId val="1694752079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6947437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62CF93B-3F69-4AC2-66BD-1F3605787C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1AC64F2-EE64-24DD-5CAC-5F8A236DEA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2EB8A13-576F-8D70-F15B-C0F1C00C9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1F42ECF-0966-D8CB-C8A2-D505FCBB3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4A9AD0-C7B6-E88B-6DED-3986A67AB3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410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855074D-9B9A-BDB5-D975-AA63320B11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615D74B-3FD7-8F9F-D516-81FFB89D5D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E621235-798E-B28A-F0A2-1BD0B0224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FE2D075-E5C3-D6FC-C94B-2742677AA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3F63703-A485-4F3F-A5E0-2AC4B2AE9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124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B79AE2CC-D9D8-88BF-27DA-D3C7DA2095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20A72AB-02CA-461F-3378-58FC2E5D03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DA4F0AB-BA88-8762-5D15-F54398514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5C96304-34FD-6337-3B0E-598AF39F8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43FFE86-56F5-9AC8-EF0F-2C427DE30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567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E23ADF-9B7A-0BAC-E9DD-41E0014AA2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1B257EC-EAFC-0DCE-6399-D8BEA1CCF4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FFF5E9E-C419-755F-A41C-84F010A4E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B5F6B69-C3DC-F103-1E2D-E1E5FDC42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4CF54DD-C99A-FA9D-5A5E-8E88A3715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753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1ECA7B5-9745-EEED-0328-5CEB924005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CED274F-399B-692E-A753-CD51BD27A1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9A6DDF4-2E58-0239-8BF0-8ACB7EF84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B446CE5-CED3-C70F-27B7-E893FEFF8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A929C58-6EB1-1945-08D3-E043EBEE7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536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2182CE3-B397-FE6C-982B-2A43177F3C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BDB9BEA-DC16-F7B8-AD8B-90B529EC3B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E732779-08BA-FE05-5A7C-FC2FEAC219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E2A97AB-0C50-75D2-BF0D-D8DCA67E6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6180465-56F3-C1ED-C37A-8DB61C53D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75B6255-9050-DAD3-E322-A2E0835B7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401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15773CE-8DBC-9C08-28D3-75665D02C3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7ABD1EB-4DCD-8F9C-27E3-59F7B82855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45F121E-7F27-5A98-33D9-D4B79A3590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5D0360A-BABA-6E88-C25D-E31755A256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FC882201-2839-CBA7-2A0E-694B6F93C5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BC8BE72-C087-EBC0-ADB1-BDCB68A7E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B63FAE17-1452-413D-379D-5F9B50E648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B9EC74B-4EB5-35D7-046D-F78A7F71A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742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7FD0C56-55E2-4757-02D2-A4B646FEA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F97ACBA-0CFE-76A5-5E26-C1F7839E6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1F82BBD-A135-28E4-FD15-0155CA44EB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2DDEDF4-E60F-B1D5-0B62-5ED3128DD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507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4CBBB2A5-B58F-7ACE-022B-73C4B1F2BB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11D822A-66A5-33E1-013E-9704B4EF2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DA7C801B-2018-3B8F-E4F4-CE46C9527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8194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ACA47B4-5428-F472-0F25-454F135420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26BB935-3E90-649A-8454-28D20F2440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ACBA6CA-252B-08D1-E579-306E5D08AE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9B18B6B-82EC-9BCA-16CC-AED95D30A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39B95EC-1D4A-27C1-5DDD-6C55BB0EF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65FA2BB-0A34-FEEA-F57C-DB1E66E88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8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7DC12B3-0019-BD04-99C7-CFFD074E2C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9AF3BF8-93D4-DD75-76C1-7C2F95635F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B849813-4B76-4EBF-6940-23A4E36421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C510F0C-5A9B-2BBA-DE2C-E194279FA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C5685E3-F90C-9659-BA67-79E5F1521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F1FFBB7-0297-C13A-C5E7-DCE68166A0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877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28B7870-604B-573F-43D6-2E7EF03D5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30853F7-278B-8FF8-272D-251E4D5B8F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1539FC1-8AA4-0459-1F67-0CEC15F8EE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DD4BB-71A9-4B93-836A-FE44DEB51058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B5BCFD8-37A7-552C-9EE7-5FF621D911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3140146-81B8-C0B1-EF83-3780665F04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5893C-BF1E-4A63-8AFD-1B7C84BCC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731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>
            <a:extLst>
              <a:ext uri="{FF2B5EF4-FFF2-40B4-BE49-F238E27FC236}">
                <a16:creationId xmlns:a16="http://schemas.microsoft.com/office/drawing/2014/main" id="{C46EA5A8-8C78-4A74-91AF-97C2F9D910D5}"/>
              </a:ext>
            </a:extLst>
          </p:cNvPr>
          <p:cNvGrpSpPr/>
          <p:nvPr/>
        </p:nvGrpSpPr>
        <p:grpSpPr>
          <a:xfrm>
            <a:off x="1034709" y="1262811"/>
            <a:ext cx="9866109" cy="4145033"/>
            <a:chOff x="147486" y="1745967"/>
            <a:chExt cx="12044514" cy="3464661"/>
          </a:xfrm>
        </p:grpSpPr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C99A2567-9A29-9E05-E856-6001D4D2C7DA}"/>
                </a:ext>
              </a:extLst>
            </p:cNvPr>
            <p:cNvGrpSpPr/>
            <p:nvPr/>
          </p:nvGrpSpPr>
          <p:grpSpPr>
            <a:xfrm>
              <a:off x="147883" y="1772058"/>
              <a:ext cx="12044117" cy="3438570"/>
              <a:chOff x="147883" y="1772058"/>
              <a:chExt cx="12044117" cy="3438570"/>
            </a:xfrm>
          </p:grpSpPr>
          <p:grpSp>
            <p:nvGrpSpPr>
              <p:cNvPr id="11" name="그룹 10">
                <a:extLst>
                  <a:ext uri="{FF2B5EF4-FFF2-40B4-BE49-F238E27FC236}">
                    <a16:creationId xmlns:a16="http://schemas.microsoft.com/office/drawing/2014/main" id="{7BB6D2CA-0BF2-D835-C86C-6BA49A51A280}"/>
                  </a:ext>
                </a:extLst>
              </p:cNvPr>
              <p:cNvGrpSpPr/>
              <p:nvPr/>
            </p:nvGrpSpPr>
            <p:grpSpPr>
              <a:xfrm>
                <a:off x="147883" y="1772058"/>
                <a:ext cx="12044117" cy="3438570"/>
                <a:chOff x="147883" y="1772058"/>
                <a:chExt cx="12044117" cy="3438570"/>
              </a:xfrm>
            </p:grpSpPr>
            <p:graphicFrame>
              <p:nvGraphicFramePr>
                <p:cNvPr id="13" name="Chart 1">
                  <a:extLst>
                    <a:ext uri="{FF2B5EF4-FFF2-40B4-BE49-F238E27FC236}">
                      <a16:creationId xmlns:a16="http://schemas.microsoft.com/office/drawing/2014/main" id="{90910013-5646-A81B-555D-797410570236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234763816"/>
                    </p:ext>
                  </p:extLst>
                </p:nvPr>
              </p:nvGraphicFramePr>
              <p:xfrm>
                <a:off x="6893986" y="1994433"/>
                <a:ext cx="5298014" cy="321619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14" name="Chart 2">
                  <a:extLst>
                    <a:ext uri="{FF2B5EF4-FFF2-40B4-BE49-F238E27FC236}">
                      <a16:creationId xmlns:a16="http://schemas.microsoft.com/office/drawing/2014/main" id="{57821A8A-2868-B9D8-6228-F483E71AB677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43568162"/>
                    </p:ext>
                  </p:extLst>
                </p:nvPr>
              </p:nvGraphicFramePr>
              <p:xfrm>
                <a:off x="824596" y="1994433"/>
                <a:ext cx="5298014" cy="321619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EC8F465B-E44B-8A42-8221-83D1D6AE95FA}"/>
                    </a:ext>
                  </a:extLst>
                </p:cNvPr>
                <p:cNvSpPr txBox="1"/>
                <p:nvPr/>
              </p:nvSpPr>
              <p:spPr>
                <a:xfrm rot="10800000">
                  <a:off x="147883" y="1834776"/>
                  <a:ext cx="676319" cy="3116426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expression level</a:t>
                  </a:r>
                </a:p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en-US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Log₂FC</a:t>
                  </a: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D3D29250-8519-BC77-BCC7-E5F3BB90BDD1}"/>
                    </a:ext>
                  </a:extLst>
                </p:cNvPr>
                <p:cNvSpPr txBox="1"/>
                <p:nvPr/>
              </p:nvSpPr>
              <p:spPr>
                <a:xfrm>
                  <a:off x="2431239" y="1772058"/>
                  <a:ext cx="2418643" cy="205806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000" b="1" kern="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Fxa6Bg1786910 (</a:t>
                  </a:r>
                  <a:r>
                    <a:rPr lang="en-US" altLang="ko-KR" sz="1000" b="1" i="1" kern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aLRK10A</a:t>
                  </a:r>
                  <a:r>
                    <a:rPr lang="en-US" altLang="ko-KR" sz="1000" b="1" kern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3555AA70-B1DA-9DE8-57CC-3423B3BC5264}"/>
                    </a:ext>
                  </a:extLst>
                </p:cNvPr>
                <p:cNvSpPr txBox="1"/>
                <p:nvPr/>
              </p:nvSpPr>
              <p:spPr>
                <a:xfrm rot="10800000">
                  <a:off x="6188021" y="1834776"/>
                  <a:ext cx="676319" cy="3116426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expression level</a:t>
                  </a:r>
                </a:p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en-US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Log₂FC</a:t>
                  </a: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</p:grp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377A176-2332-7B09-40A0-151581351E5E}"/>
                  </a:ext>
                </a:extLst>
              </p:cNvPr>
              <p:cNvSpPr txBox="1"/>
              <p:nvPr/>
            </p:nvSpPr>
            <p:spPr>
              <a:xfrm>
                <a:off x="8548799" y="1772058"/>
                <a:ext cx="2417178" cy="20580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1000" b="1" kern="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Fxa6Bg1786920 (</a:t>
                </a:r>
                <a:r>
                  <a:rPr lang="en-US" altLang="ko-KR" sz="1000" b="1" i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FaLRK10B</a:t>
                </a:r>
                <a:r>
                  <a:rPr lang="en-US" altLang="ko-KR" sz="1000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r>
                  <a:rPr lang="en-US" altLang="ko-KR" sz="1000" b="1" kern="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504CED6-1ECC-4A19-F276-719422D2C407}"/>
                </a:ext>
              </a:extLst>
            </p:cNvPr>
            <p:cNvSpPr txBox="1"/>
            <p:nvPr/>
          </p:nvSpPr>
          <p:spPr>
            <a:xfrm>
              <a:off x="147486" y="1745967"/>
              <a:ext cx="338745" cy="2315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839FE6E-F80E-AC73-A6D0-6B282DEBAB00}"/>
                </a:ext>
              </a:extLst>
            </p:cNvPr>
            <p:cNvSpPr txBox="1"/>
            <p:nvPr/>
          </p:nvSpPr>
          <p:spPr>
            <a:xfrm>
              <a:off x="6216686" y="1745967"/>
              <a:ext cx="338745" cy="2315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6DCED538-397A-D0CF-849F-FDA41ECDF7BF}"/>
              </a:ext>
            </a:extLst>
          </p:cNvPr>
          <p:cNvSpPr txBox="1"/>
          <p:nvPr/>
        </p:nvSpPr>
        <p:spPr>
          <a:xfrm rot="16200000">
            <a:off x="6748593" y="4704589"/>
            <a:ext cx="6790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2548630-2757-AF69-4F55-5D1C8ED9344C}"/>
              </a:ext>
            </a:extLst>
          </p:cNvPr>
          <p:cNvSpPr txBox="1"/>
          <p:nvPr/>
        </p:nvSpPr>
        <p:spPr>
          <a:xfrm rot="16200000">
            <a:off x="7059396" y="4704589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1295612-A67B-69D8-40E6-D0A92CE3DA27}"/>
              </a:ext>
            </a:extLst>
          </p:cNvPr>
          <p:cNvSpPr txBox="1"/>
          <p:nvPr/>
        </p:nvSpPr>
        <p:spPr>
          <a:xfrm rot="16200000">
            <a:off x="7376129" y="4704589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E4C29AE-59B7-934A-B942-871A76544B01}"/>
              </a:ext>
            </a:extLst>
          </p:cNvPr>
          <p:cNvSpPr txBox="1"/>
          <p:nvPr/>
        </p:nvSpPr>
        <p:spPr>
          <a:xfrm rot="16200000">
            <a:off x="7702997" y="4704589"/>
            <a:ext cx="6790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52BD1FE-234F-4594-0F55-E68961BEF67D}"/>
              </a:ext>
            </a:extLst>
          </p:cNvPr>
          <p:cNvSpPr txBox="1"/>
          <p:nvPr/>
        </p:nvSpPr>
        <p:spPr>
          <a:xfrm rot="16200000">
            <a:off x="8013800" y="4704589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55992B6-411F-1C5C-467F-814260A24BCF}"/>
              </a:ext>
            </a:extLst>
          </p:cNvPr>
          <p:cNvSpPr txBox="1"/>
          <p:nvPr/>
        </p:nvSpPr>
        <p:spPr>
          <a:xfrm rot="16200000">
            <a:off x="8279196" y="4704585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750FA69-0968-C5E9-B783-2D36728368CD}"/>
              </a:ext>
            </a:extLst>
          </p:cNvPr>
          <p:cNvSpPr txBox="1"/>
          <p:nvPr/>
        </p:nvSpPr>
        <p:spPr>
          <a:xfrm rot="16200000">
            <a:off x="8683092" y="4704584"/>
            <a:ext cx="6790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7D9E881-B348-3E9D-E0F1-C3A1733D68FB}"/>
              </a:ext>
            </a:extLst>
          </p:cNvPr>
          <p:cNvSpPr txBox="1"/>
          <p:nvPr/>
        </p:nvSpPr>
        <p:spPr>
          <a:xfrm rot="16200000">
            <a:off x="8947572" y="4704588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B5E608E-7240-259B-FF41-F7DEA64F4480}"/>
              </a:ext>
            </a:extLst>
          </p:cNvPr>
          <p:cNvSpPr txBox="1"/>
          <p:nvPr/>
        </p:nvSpPr>
        <p:spPr>
          <a:xfrm rot="16200000">
            <a:off x="9254611" y="4704583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79114E3-4F3F-264D-B6BF-B93CEB70428E}"/>
              </a:ext>
            </a:extLst>
          </p:cNvPr>
          <p:cNvSpPr txBox="1"/>
          <p:nvPr/>
        </p:nvSpPr>
        <p:spPr>
          <a:xfrm rot="16200000">
            <a:off x="9615949" y="4732575"/>
            <a:ext cx="6790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0C9B377-B655-EC67-574B-7527D5809E25}"/>
              </a:ext>
            </a:extLst>
          </p:cNvPr>
          <p:cNvSpPr txBox="1"/>
          <p:nvPr/>
        </p:nvSpPr>
        <p:spPr>
          <a:xfrm rot="16200000">
            <a:off x="9892282" y="4732575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2AC2EEE-A5F3-B361-F01B-51E82908F934}"/>
              </a:ext>
            </a:extLst>
          </p:cNvPr>
          <p:cNvSpPr txBox="1"/>
          <p:nvPr/>
        </p:nvSpPr>
        <p:spPr>
          <a:xfrm rot="16200000">
            <a:off x="10247095" y="4732574"/>
            <a:ext cx="67908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1B3EA44-637F-7E83-94F9-D867EA8932B1}"/>
              </a:ext>
            </a:extLst>
          </p:cNvPr>
          <p:cNvSpPr txBox="1"/>
          <p:nvPr/>
        </p:nvSpPr>
        <p:spPr>
          <a:xfrm rot="16200000">
            <a:off x="1761756" y="4704588"/>
            <a:ext cx="6790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4651F7B-7DB3-0F15-F83E-FF1C43EF7BEA}"/>
              </a:ext>
            </a:extLst>
          </p:cNvPr>
          <p:cNvSpPr txBox="1"/>
          <p:nvPr/>
        </p:nvSpPr>
        <p:spPr>
          <a:xfrm rot="16200000">
            <a:off x="2072559" y="4704588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60CC757-E52E-E7B8-3153-FC898A38C1BB}"/>
              </a:ext>
            </a:extLst>
          </p:cNvPr>
          <p:cNvSpPr txBox="1"/>
          <p:nvPr/>
        </p:nvSpPr>
        <p:spPr>
          <a:xfrm rot="16200000">
            <a:off x="2408945" y="4704586"/>
            <a:ext cx="67908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C91B363-6658-E199-A4BE-9539D4534C2B}"/>
              </a:ext>
            </a:extLst>
          </p:cNvPr>
          <p:cNvSpPr txBox="1"/>
          <p:nvPr/>
        </p:nvSpPr>
        <p:spPr>
          <a:xfrm rot="16200000">
            <a:off x="2723615" y="4704588"/>
            <a:ext cx="6790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2788E82-60CE-AFA1-7F29-12472FEF08D3}"/>
              </a:ext>
            </a:extLst>
          </p:cNvPr>
          <p:cNvSpPr txBox="1"/>
          <p:nvPr/>
        </p:nvSpPr>
        <p:spPr>
          <a:xfrm rot="16200000">
            <a:off x="3034418" y="4704588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45A8CEB-59B5-5447-A7EB-20C40EF83E70}"/>
              </a:ext>
            </a:extLst>
          </p:cNvPr>
          <p:cNvSpPr txBox="1"/>
          <p:nvPr/>
        </p:nvSpPr>
        <p:spPr>
          <a:xfrm rot="16200000">
            <a:off x="3389231" y="4704587"/>
            <a:ext cx="67908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DA9D014-AFF5-B4A3-0809-0744EBBABAA1}"/>
              </a:ext>
            </a:extLst>
          </p:cNvPr>
          <p:cNvSpPr txBox="1"/>
          <p:nvPr/>
        </p:nvSpPr>
        <p:spPr>
          <a:xfrm rot="16200000">
            <a:off x="3682768" y="4704587"/>
            <a:ext cx="6790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DB6C379-D97C-6CBA-6DA5-DF918C7B9AF3}"/>
              </a:ext>
            </a:extLst>
          </p:cNvPr>
          <p:cNvSpPr txBox="1"/>
          <p:nvPr/>
        </p:nvSpPr>
        <p:spPr>
          <a:xfrm rot="16200000">
            <a:off x="3993571" y="4704587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F360EF5-C81E-7D67-FB6F-EDED8AD87011}"/>
              </a:ext>
            </a:extLst>
          </p:cNvPr>
          <p:cNvSpPr txBox="1"/>
          <p:nvPr/>
        </p:nvSpPr>
        <p:spPr>
          <a:xfrm rot="16200000">
            <a:off x="4348384" y="4704586"/>
            <a:ext cx="67908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018C432-BBB5-A969-42C8-F3A24589925B}"/>
              </a:ext>
            </a:extLst>
          </p:cNvPr>
          <p:cNvSpPr txBox="1"/>
          <p:nvPr/>
        </p:nvSpPr>
        <p:spPr>
          <a:xfrm rot="16200000">
            <a:off x="4641921" y="4704587"/>
            <a:ext cx="6790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93781DA-9024-78F1-A141-32EEA0F3FACC}"/>
              </a:ext>
            </a:extLst>
          </p:cNvPr>
          <p:cNvSpPr txBox="1"/>
          <p:nvPr/>
        </p:nvSpPr>
        <p:spPr>
          <a:xfrm rot="16200000">
            <a:off x="4952724" y="4704587"/>
            <a:ext cx="6790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32261C3-7812-120C-B7C9-A1D72EE61064}"/>
              </a:ext>
            </a:extLst>
          </p:cNvPr>
          <p:cNvSpPr txBox="1"/>
          <p:nvPr/>
        </p:nvSpPr>
        <p:spPr>
          <a:xfrm rot="16200000">
            <a:off x="5307537" y="4704586"/>
            <a:ext cx="67908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a1Ca1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828044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50</Words>
  <Application>Microsoft Office PowerPoint</Application>
  <PresentationFormat>와이드스크린</PresentationFormat>
  <Paragraphs>3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n, Hyeondae</dc:creator>
  <cp:lastModifiedBy>Yoon Jeong Jang</cp:lastModifiedBy>
  <cp:revision>6</cp:revision>
  <dcterms:created xsi:type="dcterms:W3CDTF">2024-03-17T21:00:19Z</dcterms:created>
  <dcterms:modified xsi:type="dcterms:W3CDTF">2024-09-30T09:06:13Z</dcterms:modified>
</cp:coreProperties>
</file>